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3328B352-228A-42AD-804C-53F302AAF6C2}" v="1" dt="2024-10-10T06:50:29.347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934" autoAdjust="0"/>
    <p:restoredTop sz="94660"/>
  </p:normalViewPr>
  <p:slideViewPr>
    <p:cSldViewPr snapToGrid="0">
      <p:cViewPr varScale="1">
        <p:scale>
          <a:sx n="73" d="100"/>
          <a:sy n="73" d="100"/>
        </p:scale>
        <p:origin x="1908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赤堀　ゆきこ" userId="bbfeda90-9ade-440e-995a-5a1e8cff3baf" providerId="ADAL" clId="{3328B352-228A-42AD-804C-53F302AAF6C2}"/>
    <pc:docChg chg="addSld delSld modSld">
      <pc:chgData name="赤堀　ゆきこ" userId="bbfeda90-9ade-440e-995a-5a1e8cff3baf" providerId="ADAL" clId="{3328B352-228A-42AD-804C-53F302AAF6C2}" dt="2024-10-10T07:17:16.635" v="6" actId="20577"/>
      <pc:docMkLst>
        <pc:docMk/>
      </pc:docMkLst>
      <pc:sldChg chg="modSp add mod">
        <pc:chgData name="赤堀　ゆきこ" userId="bbfeda90-9ade-440e-995a-5a1e8cff3baf" providerId="ADAL" clId="{3328B352-228A-42AD-804C-53F302AAF6C2}" dt="2024-10-10T07:17:16.635" v="6" actId="20577"/>
        <pc:sldMkLst>
          <pc:docMk/>
          <pc:sldMk cId="2071845089" sldId="256"/>
        </pc:sldMkLst>
        <pc:graphicFrameChg chg="modGraphic">
          <ac:chgData name="赤堀　ゆきこ" userId="bbfeda90-9ade-440e-995a-5a1e8cff3baf" providerId="ADAL" clId="{3328B352-228A-42AD-804C-53F302AAF6C2}" dt="2024-10-10T07:17:16.635" v="6" actId="20577"/>
          <ac:graphicFrameMkLst>
            <pc:docMk/>
            <pc:sldMk cId="2071845089" sldId="256"/>
            <ac:graphicFrameMk id="4" creationId="{73D324E8-FD26-676B-7AA5-E3F27788956B}"/>
          </ac:graphicFrameMkLst>
        </pc:graphicFrameChg>
      </pc:sldChg>
      <pc:sldChg chg="del">
        <pc:chgData name="赤堀　ゆきこ" userId="bbfeda90-9ade-440e-995a-5a1e8cff3baf" providerId="ADAL" clId="{3328B352-228A-42AD-804C-53F302AAF6C2}" dt="2024-10-10T06:50:30.571" v="1" actId="47"/>
        <pc:sldMkLst>
          <pc:docMk/>
          <pc:sldMk cId="1509033053" sldId="257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E0BBB-3399-4401-875A-1370C28E4E37}" type="datetimeFigureOut">
              <a:rPr kumimoji="1" lang="ja-JP" altLang="en-US" smtClean="0"/>
              <a:t>2024/10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A8580-E68A-4957-9555-572C0B1A6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572278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E0BBB-3399-4401-875A-1370C28E4E37}" type="datetimeFigureOut">
              <a:rPr kumimoji="1" lang="ja-JP" altLang="en-US" smtClean="0"/>
              <a:t>2024/10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A8580-E68A-4957-9555-572C0B1A6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189498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E0BBB-3399-4401-875A-1370C28E4E37}" type="datetimeFigureOut">
              <a:rPr kumimoji="1" lang="ja-JP" altLang="en-US" smtClean="0"/>
              <a:t>2024/10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A8580-E68A-4957-9555-572C0B1A6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252621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E0BBB-3399-4401-875A-1370C28E4E37}" type="datetimeFigureOut">
              <a:rPr kumimoji="1" lang="ja-JP" altLang="en-US" smtClean="0"/>
              <a:t>2024/10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A8580-E68A-4957-9555-572C0B1A6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553839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E0BBB-3399-4401-875A-1370C28E4E37}" type="datetimeFigureOut">
              <a:rPr kumimoji="1" lang="ja-JP" altLang="en-US" smtClean="0"/>
              <a:t>2024/10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A8580-E68A-4957-9555-572C0B1A6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167064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E0BBB-3399-4401-875A-1370C28E4E37}" type="datetimeFigureOut">
              <a:rPr kumimoji="1" lang="ja-JP" altLang="en-US" smtClean="0"/>
              <a:t>2024/10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A8580-E68A-4957-9555-572C0B1A6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126367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E0BBB-3399-4401-875A-1370C28E4E37}" type="datetimeFigureOut">
              <a:rPr kumimoji="1" lang="ja-JP" altLang="en-US" smtClean="0"/>
              <a:t>2024/10/1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A8580-E68A-4957-9555-572C0B1A6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76365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E0BBB-3399-4401-875A-1370C28E4E37}" type="datetimeFigureOut">
              <a:rPr kumimoji="1" lang="ja-JP" altLang="en-US" smtClean="0"/>
              <a:t>2024/10/1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A8580-E68A-4957-9555-572C0B1A6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035102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E0BBB-3399-4401-875A-1370C28E4E37}" type="datetimeFigureOut">
              <a:rPr kumimoji="1" lang="ja-JP" altLang="en-US" smtClean="0"/>
              <a:t>2024/10/1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A8580-E68A-4957-9555-572C0B1A6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96126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E0BBB-3399-4401-875A-1370C28E4E37}" type="datetimeFigureOut">
              <a:rPr kumimoji="1" lang="ja-JP" altLang="en-US" smtClean="0"/>
              <a:t>2024/10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A8580-E68A-4957-9555-572C0B1A6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876398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E0BBB-3399-4401-875A-1370C28E4E37}" type="datetimeFigureOut">
              <a:rPr kumimoji="1" lang="ja-JP" altLang="en-US" smtClean="0"/>
              <a:t>2024/10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A8580-E68A-4957-9555-572C0B1A6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106160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72E0BBB-3399-4401-875A-1370C28E4E37}" type="datetimeFigureOut">
              <a:rPr kumimoji="1" lang="ja-JP" altLang="en-US" smtClean="0"/>
              <a:t>2024/10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CCA8580-E68A-4957-9555-572C0B1A6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633147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3">
            <a:extLst>
              <a:ext uri="{FF2B5EF4-FFF2-40B4-BE49-F238E27FC236}">
                <a16:creationId xmlns:a16="http://schemas.microsoft.com/office/drawing/2014/main" id="{73D324E8-FD26-676B-7AA5-E3F27788956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72642441"/>
              </p:ext>
            </p:extLst>
          </p:nvPr>
        </p:nvGraphicFramePr>
        <p:xfrm>
          <a:off x="397822" y="3605564"/>
          <a:ext cx="6062355" cy="1328082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640246">
                  <a:extLst>
                    <a:ext uri="{9D8B030D-6E8A-4147-A177-3AD203B41FA5}">
                      <a16:colId xmlns:a16="http://schemas.microsoft.com/office/drawing/2014/main" val="1060307410"/>
                    </a:ext>
                  </a:extLst>
                </a:gridCol>
                <a:gridCol w="492919">
                  <a:extLst>
                    <a:ext uri="{9D8B030D-6E8A-4147-A177-3AD203B41FA5}">
                      <a16:colId xmlns:a16="http://schemas.microsoft.com/office/drawing/2014/main" val="3329893708"/>
                    </a:ext>
                  </a:extLst>
                </a:gridCol>
                <a:gridCol w="492919">
                  <a:extLst>
                    <a:ext uri="{9D8B030D-6E8A-4147-A177-3AD203B41FA5}">
                      <a16:colId xmlns:a16="http://schemas.microsoft.com/office/drawing/2014/main" val="554137029"/>
                    </a:ext>
                  </a:extLst>
                </a:gridCol>
                <a:gridCol w="492919">
                  <a:extLst>
                    <a:ext uri="{9D8B030D-6E8A-4147-A177-3AD203B41FA5}">
                      <a16:colId xmlns:a16="http://schemas.microsoft.com/office/drawing/2014/main" val="2748198002"/>
                    </a:ext>
                  </a:extLst>
                </a:gridCol>
                <a:gridCol w="492919">
                  <a:extLst>
                    <a:ext uri="{9D8B030D-6E8A-4147-A177-3AD203B41FA5}">
                      <a16:colId xmlns:a16="http://schemas.microsoft.com/office/drawing/2014/main" val="4230570538"/>
                    </a:ext>
                  </a:extLst>
                </a:gridCol>
                <a:gridCol w="492919">
                  <a:extLst>
                    <a:ext uri="{9D8B030D-6E8A-4147-A177-3AD203B41FA5}">
                      <a16:colId xmlns:a16="http://schemas.microsoft.com/office/drawing/2014/main" val="1958776474"/>
                    </a:ext>
                  </a:extLst>
                </a:gridCol>
                <a:gridCol w="492919">
                  <a:extLst>
                    <a:ext uri="{9D8B030D-6E8A-4147-A177-3AD203B41FA5}">
                      <a16:colId xmlns:a16="http://schemas.microsoft.com/office/drawing/2014/main" val="2812888658"/>
                    </a:ext>
                  </a:extLst>
                </a:gridCol>
                <a:gridCol w="492919">
                  <a:extLst>
                    <a:ext uri="{9D8B030D-6E8A-4147-A177-3AD203B41FA5}">
                      <a16:colId xmlns:a16="http://schemas.microsoft.com/office/drawing/2014/main" val="1163363560"/>
                    </a:ext>
                  </a:extLst>
                </a:gridCol>
                <a:gridCol w="492919">
                  <a:extLst>
                    <a:ext uri="{9D8B030D-6E8A-4147-A177-3AD203B41FA5}">
                      <a16:colId xmlns:a16="http://schemas.microsoft.com/office/drawing/2014/main" val="1971869677"/>
                    </a:ext>
                  </a:extLst>
                </a:gridCol>
                <a:gridCol w="492919">
                  <a:extLst>
                    <a:ext uri="{9D8B030D-6E8A-4147-A177-3AD203B41FA5}">
                      <a16:colId xmlns:a16="http://schemas.microsoft.com/office/drawing/2014/main" val="2213449836"/>
                    </a:ext>
                  </a:extLst>
                </a:gridCol>
                <a:gridCol w="492919">
                  <a:extLst>
                    <a:ext uri="{9D8B030D-6E8A-4147-A177-3AD203B41FA5}">
                      <a16:colId xmlns:a16="http://schemas.microsoft.com/office/drawing/2014/main" val="2652354273"/>
                    </a:ext>
                  </a:extLst>
                </a:gridCol>
                <a:gridCol w="492919">
                  <a:extLst>
                    <a:ext uri="{9D8B030D-6E8A-4147-A177-3AD203B41FA5}">
                      <a16:colId xmlns:a16="http://schemas.microsoft.com/office/drawing/2014/main" val="2634005073"/>
                    </a:ext>
                  </a:extLst>
                </a:gridCol>
              </a:tblGrid>
              <a:tr h="150614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rotyp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/>
                </a:tc>
                <a:tc gridSpan="11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hibitory zone (mm</a:t>
                      </a:r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23453690"/>
                  </a:ext>
                </a:extLst>
              </a:tr>
              <a:tr h="13007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1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1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4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48011994"/>
                  </a:ext>
                </a:extLst>
              </a:tr>
              <a:tr h="138291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170581903"/>
                  </a:ext>
                </a:extLst>
              </a:tr>
              <a:tr h="138291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/>
                </a:tc>
                <a:extLst>
                  <a:ext uri="{0D108BD9-81ED-4DB2-BD59-A6C34878D82A}">
                    <a16:rowId xmlns:a16="http://schemas.microsoft.com/office/drawing/2014/main" val="523482532"/>
                  </a:ext>
                </a:extLst>
              </a:tr>
              <a:tr h="138291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37004953"/>
                  </a:ext>
                </a:extLst>
              </a:tr>
              <a:tr h="13007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verag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0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0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.0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7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0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3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0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0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.0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0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.3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636548131"/>
                  </a:ext>
                </a:extLst>
              </a:tr>
              <a:tr h="13007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DEV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/>
                </a:tc>
                <a:extLst>
                  <a:ext uri="{0D108BD9-81ED-4DB2-BD59-A6C34878D82A}">
                    <a16:rowId xmlns:a16="http://schemas.microsoft.com/office/drawing/2014/main" val="2170239637"/>
                  </a:ext>
                </a:extLst>
              </a:tr>
            </a:tbl>
          </a:graphicData>
        </a:graphic>
      </p:graphicFrame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87B7889E-A8C5-C6FF-3C1D-443E92E1E3FB}"/>
              </a:ext>
            </a:extLst>
          </p:cNvPr>
          <p:cNvSpPr txBox="1"/>
          <p:nvPr/>
        </p:nvSpPr>
        <p:spPr>
          <a:xfrm>
            <a:off x="813777" y="3048586"/>
            <a:ext cx="169790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1 dataset</a:t>
            </a:r>
          </a:p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The dataset of Fig. 1B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E1BC4405-A540-FD06-DEC4-783FEF50D996}"/>
              </a:ext>
            </a:extLst>
          </p:cNvPr>
          <p:cNvSpPr txBox="1"/>
          <p:nvPr/>
        </p:nvSpPr>
        <p:spPr>
          <a:xfrm>
            <a:off x="813777" y="2793452"/>
            <a:ext cx="1552028" cy="25513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8" dirty="0">
                <a:latin typeface="Arial" panose="020B0604020202020204" pitchFamily="34" charset="0"/>
                <a:cs typeface="Arial" panose="020B0604020202020204" pitchFamily="34" charset="0"/>
              </a:rPr>
              <a:t>Supporting information</a:t>
            </a:r>
            <a:endParaRPr lang="ja-JP" altLang="en-US" sz="1058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718450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テーマ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</TotalTime>
  <Words>87</Words>
  <Application>Microsoft Office PowerPoint</Application>
  <PresentationFormat>A4 210 x 297 mm</PresentationFormat>
  <Paragraphs>76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赤堀　ゆきこ</dc:creator>
  <cp:lastModifiedBy>赤堀　ゆきこ</cp:lastModifiedBy>
  <cp:revision>3</cp:revision>
  <dcterms:created xsi:type="dcterms:W3CDTF">2024-10-10T06:46:11Z</dcterms:created>
  <dcterms:modified xsi:type="dcterms:W3CDTF">2024-10-10T07:17:17Z</dcterms:modified>
</cp:coreProperties>
</file>